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91" r:id="rId5"/>
    <p:sldId id="271" r:id="rId6"/>
    <p:sldId id="284" r:id="rId7"/>
    <p:sldId id="285" r:id="rId8"/>
    <p:sldId id="289" r:id="rId9"/>
    <p:sldId id="290" r:id="rId10"/>
    <p:sldId id="287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50" userDrawn="1">
          <p15:clr>
            <a:srgbClr val="A4A3A4"/>
          </p15:clr>
        </p15:guide>
        <p15:guide id="2" pos="35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4125C1C-6EE8-48AA-862A-60C1C2A0EFF6}" v="1" dt="2023-05-02T05:23:43.71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5" d="100"/>
          <a:sy n="75" d="100"/>
        </p:scale>
        <p:origin x="1594" y="48"/>
      </p:cViewPr>
      <p:guideLst>
        <p:guide orient="horz" pos="2750"/>
        <p:guide pos="35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anna Melonek" userId="7d4de3f2-3323-486d-9e49-4ecbf3eebe79" providerId="ADAL" clId="{C4125C1C-6EE8-48AA-862A-60C1C2A0EFF6}"/>
    <pc:docChg chg="custSel addSld modSld sldOrd">
      <pc:chgData name="Joanna Melonek" userId="7d4de3f2-3323-486d-9e49-4ecbf3eebe79" providerId="ADAL" clId="{C4125C1C-6EE8-48AA-862A-60C1C2A0EFF6}" dt="2023-05-02T06:47:10.618" v="79" actId="20577"/>
      <pc:docMkLst>
        <pc:docMk/>
      </pc:docMkLst>
      <pc:sldChg chg="modSp mod">
        <pc:chgData name="Joanna Melonek" userId="7d4de3f2-3323-486d-9e49-4ecbf3eebe79" providerId="ADAL" clId="{C4125C1C-6EE8-48AA-862A-60C1C2A0EFF6}" dt="2023-05-02T05:19:46.664" v="3" actId="20577"/>
        <pc:sldMkLst>
          <pc:docMk/>
          <pc:sldMk cId="404553875" sldId="285"/>
        </pc:sldMkLst>
        <pc:spChg chg="mod">
          <ac:chgData name="Joanna Melonek" userId="7d4de3f2-3323-486d-9e49-4ecbf3eebe79" providerId="ADAL" clId="{C4125C1C-6EE8-48AA-862A-60C1C2A0EFF6}" dt="2023-05-02T05:19:46.664" v="3" actId="20577"/>
          <ac:spMkLst>
            <pc:docMk/>
            <pc:sldMk cId="404553875" sldId="285"/>
            <ac:spMk id="2" creationId="{EFA8D3B1-3531-9A1E-523E-F00A721F3890}"/>
          </ac:spMkLst>
        </pc:spChg>
      </pc:sldChg>
      <pc:sldChg chg="modSp mod">
        <pc:chgData name="Joanna Melonek" userId="7d4de3f2-3323-486d-9e49-4ecbf3eebe79" providerId="ADAL" clId="{C4125C1C-6EE8-48AA-862A-60C1C2A0EFF6}" dt="2023-05-02T05:22:30.236" v="17" actId="20577"/>
        <pc:sldMkLst>
          <pc:docMk/>
          <pc:sldMk cId="1350610973" sldId="287"/>
        </pc:sldMkLst>
        <pc:spChg chg="mod">
          <ac:chgData name="Joanna Melonek" userId="7d4de3f2-3323-486d-9e49-4ecbf3eebe79" providerId="ADAL" clId="{C4125C1C-6EE8-48AA-862A-60C1C2A0EFF6}" dt="2023-05-02T05:22:30.236" v="17" actId="20577"/>
          <ac:spMkLst>
            <pc:docMk/>
            <pc:sldMk cId="1350610973" sldId="287"/>
            <ac:spMk id="39" creationId="{A21AAAF2-9476-F74F-544F-5621F51EC161}"/>
          </ac:spMkLst>
        </pc:spChg>
      </pc:sldChg>
      <pc:sldChg chg="modSp mod">
        <pc:chgData name="Joanna Melonek" userId="7d4de3f2-3323-486d-9e49-4ecbf3eebe79" providerId="ADAL" clId="{C4125C1C-6EE8-48AA-862A-60C1C2A0EFF6}" dt="2023-05-02T05:20:50.114" v="6" actId="20577"/>
        <pc:sldMkLst>
          <pc:docMk/>
          <pc:sldMk cId="1524701509" sldId="289"/>
        </pc:sldMkLst>
        <pc:spChg chg="mod">
          <ac:chgData name="Joanna Melonek" userId="7d4de3f2-3323-486d-9e49-4ecbf3eebe79" providerId="ADAL" clId="{C4125C1C-6EE8-48AA-862A-60C1C2A0EFF6}" dt="2023-05-02T05:20:50.114" v="6" actId="20577"/>
          <ac:spMkLst>
            <pc:docMk/>
            <pc:sldMk cId="1524701509" sldId="289"/>
            <ac:spMk id="19" creationId="{369C3757-CE16-4966-4E6E-8B9D061DA946}"/>
          </ac:spMkLst>
        </pc:spChg>
      </pc:sldChg>
      <pc:sldChg chg="modSp mod">
        <pc:chgData name="Joanna Melonek" userId="7d4de3f2-3323-486d-9e49-4ecbf3eebe79" providerId="ADAL" clId="{C4125C1C-6EE8-48AA-862A-60C1C2A0EFF6}" dt="2023-05-02T05:21:37.591" v="9" actId="113"/>
        <pc:sldMkLst>
          <pc:docMk/>
          <pc:sldMk cId="1202621942" sldId="290"/>
        </pc:sldMkLst>
        <pc:spChg chg="mod">
          <ac:chgData name="Joanna Melonek" userId="7d4de3f2-3323-486d-9e49-4ecbf3eebe79" providerId="ADAL" clId="{C4125C1C-6EE8-48AA-862A-60C1C2A0EFF6}" dt="2023-05-02T05:21:37.591" v="9" actId="113"/>
          <ac:spMkLst>
            <pc:docMk/>
            <pc:sldMk cId="1202621942" sldId="290"/>
            <ac:spMk id="19" creationId="{369C3757-CE16-4966-4E6E-8B9D061DA946}"/>
          </ac:spMkLst>
        </pc:spChg>
      </pc:sldChg>
      <pc:sldChg chg="addSp delSp modSp new mod ord">
        <pc:chgData name="Joanna Melonek" userId="7d4de3f2-3323-486d-9e49-4ecbf3eebe79" providerId="ADAL" clId="{C4125C1C-6EE8-48AA-862A-60C1C2A0EFF6}" dt="2023-05-02T06:47:10.618" v="79" actId="20577"/>
        <pc:sldMkLst>
          <pc:docMk/>
          <pc:sldMk cId="4114074820" sldId="291"/>
        </pc:sldMkLst>
        <pc:spChg chg="del">
          <ac:chgData name="Joanna Melonek" userId="7d4de3f2-3323-486d-9e49-4ecbf3eebe79" providerId="ADAL" clId="{C4125C1C-6EE8-48AA-862A-60C1C2A0EFF6}" dt="2023-05-02T05:23:35.344" v="19" actId="478"/>
          <ac:spMkLst>
            <pc:docMk/>
            <pc:sldMk cId="4114074820" sldId="291"/>
            <ac:spMk id="2" creationId="{3F15D540-8648-E281-9173-DB86BEAC96AD}"/>
          </ac:spMkLst>
        </pc:spChg>
        <pc:spChg chg="del">
          <ac:chgData name="Joanna Melonek" userId="7d4de3f2-3323-486d-9e49-4ecbf3eebe79" providerId="ADAL" clId="{C4125C1C-6EE8-48AA-862A-60C1C2A0EFF6}" dt="2023-05-02T05:23:37.969" v="20" actId="478"/>
          <ac:spMkLst>
            <pc:docMk/>
            <pc:sldMk cId="4114074820" sldId="291"/>
            <ac:spMk id="3" creationId="{27C798D5-A3E6-1E54-96EC-483F8AF7A39C}"/>
          </ac:spMkLst>
        </pc:spChg>
        <pc:spChg chg="add mod">
          <ac:chgData name="Joanna Melonek" userId="7d4de3f2-3323-486d-9e49-4ecbf3eebe79" providerId="ADAL" clId="{C4125C1C-6EE8-48AA-862A-60C1C2A0EFF6}" dt="2023-05-02T06:47:10.618" v="79" actId="20577"/>
          <ac:spMkLst>
            <pc:docMk/>
            <pc:sldMk cId="4114074820" sldId="291"/>
            <ac:spMk id="4" creationId="{9C760F1A-7000-9D2C-E86C-009E127A05F4}"/>
          </ac:spMkLst>
        </pc:spChg>
        <pc:spChg chg="add mod">
          <ac:chgData name="Joanna Melonek" userId="7d4de3f2-3323-486d-9e49-4ecbf3eebe79" providerId="ADAL" clId="{C4125C1C-6EE8-48AA-862A-60C1C2A0EFF6}" dt="2023-05-02T05:26:39.514" v="75" actId="20577"/>
          <ac:spMkLst>
            <pc:docMk/>
            <pc:sldMk cId="4114074820" sldId="291"/>
            <ac:spMk id="6" creationId="{30554B27-4B6B-932C-2871-8438A74B2337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6455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75690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44916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9097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50932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6007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3113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02455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4925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4723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6599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363B0-502A-41DF-83CD-1CD183585F8D}" type="datetimeFigureOut">
              <a:rPr lang="en-AU" smtClean="0"/>
              <a:t>2/05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7C75B-5B22-4402-A0B4-E17026BB866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7977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ian.small@uwa.edu.au" TargetMode="External"/><Relationship Id="rId2" Type="http://schemas.openxmlformats.org/officeDocument/2006/relationships/hyperlink" Target="mailto:joanna.melonek@uwa.edu.au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paperpile.com/c/rpbeNH/OLl5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itol.embl.de/" TargetMode="External"/><Relationship Id="rId5" Type="http://schemas.openxmlformats.org/officeDocument/2006/relationships/hyperlink" Target="https://www.geneious.com/" TargetMode="External"/><Relationship Id="rId4" Type="http://schemas.openxmlformats.org/officeDocument/2006/relationships/hyperlink" Target="https://paperpile.com/c/rpbeNH/9ZN3" TargetMode="Externa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hyperlink" Target="https://itol.embl.de/" TargetMode="External"/><Relationship Id="rId3" Type="http://schemas.openxmlformats.org/officeDocument/2006/relationships/image" Target="../media/image7.png"/><Relationship Id="rId7" Type="http://schemas.openxmlformats.org/officeDocument/2006/relationships/hyperlink" Target="https://www.geneious.com/" TargetMode="External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paperpile.com/c/rpbeNH/9ZN3" TargetMode="External"/><Relationship Id="rId5" Type="http://schemas.openxmlformats.org/officeDocument/2006/relationships/hyperlink" Target="https://paperpile.com/c/rpbeNH/OLl5" TargetMode="External"/><Relationship Id="rId4" Type="http://schemas.openxmlformats.org/officeDocument/2006/relationships/image" Target="../media/image8.png"/><Relationship Id="rId9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hyperlink" Target="https://paperpile.com/c/rpbeNH/9ZN3" TargetMode="External"/><Relationship Id="rId2" Type="http://schemas.openxmlformats.org/officeDocument/2006/relationships/hyperlink" Target="https://paperpile.com/c/rpbeNH/OLl5" TargetMode="Externa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hyperlink" Target="https://www.geneious.com/" TargetMode="Externa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hyperlink" Target="https://itol.embl.de/" TargetMode="External"/><Relationship Id="rId3" Type="http://schemas.openxmlformats.org/officeDocument/2006/relationships/image" Target="../media/image12.png"/><Relationship Id="rId7" Type="http://schemas.openxmlformats.org/officeDocument/2006/relationships/hyperlink" Target="https://www.geneious.com/" TargetMode="External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paperpile.com/c/rpbeNH/9ZN3" TargetMode="External"/><Relationship Id="rId5" Type="http://schemas.openxmlformats.org/officeDocument/2006/relationships/hyperlink" Target="https://paperpile.com/c/rpbeNH/OLl5" TargetMode="External"/><Relationship Id="rId4" Type="http://schemas.openxmlformats.org/officeDocument/2006/relationships/image" Target="../media/image13.png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C760F1A-7000-9D2C-E86C-009E127A05F4}"/>
              </a:ext>
            </a:extLst>
          </p:cNvPr>
          <p:cNvSpPr txBox="1"/>
          <p:nvPr/>
        </p:nvSpPr>
        <p:spPr>
          <a:xfrm>
            <a:off x="680514" y="908720"/>
            <a:ext cx="7511415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spcBef>
                <a:spcPts val="0"/>
              </a:spcBef>
              <a:spcAft>
                <a:spcPts val="0"/>
              </a:spcAft>
            </a:pPr>
            <a:r>
              <a:rPr lang="en-AU">
                <a:latin typeface="Arial" panose="020B0604020202020204" pitchFamily="34" charset="0"/>
                <a:cs typeface="Arial" panose="020B0604020202020204" pitchFamily="34" charset="0"/>
              </a:rPr>
              <a:t>Supplementary figures </a:t>
            </a:r>
            <a:r>
              <a:rPr lang="en-AU" dirty="0">
                <a:latin typeface="Arial" panose="020B0604020202020204" pitchFamily="34" charset="0"/>
                <a:cs typeface="Arial" panose="020B0604020202020204" pitchFamily="34" charset="0"/>
              </a:rPr>
              <a:t>for: </a:t>
            </a:r>
          </a:p>
          <a:p>
            <a:pPr algn="ctr" rtl="0">
              <a:spcBef>
                <a:spcPts val="0"/>
              </a:spcBef>
              <a:spcAft>
                <a:spcPts val="0"/>
              </a:spcAft>
            </a:pPr>
            <a:r>
              <a:rPr lang="en-AU" dirty="0">
                <a:latin typeface="Arial" panose="020B0604020202020204" pitchFamily="34" charset="0"/>
                <a:cs typeface="Arial" panose="020B0604020202020204" pitchFamily="34" charset="0"/>
              </a:rPr>
              <a:t>‘</a:t>
            </a:r>
            <a:r>
              <a:rPr lang="en-US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 unique C-terminal domain contributes to the molecular function </a:t>
            </a:r>
          </a:p>
          <a:p>
            <a:pPr algn="ctr" rtl="0">
              <a:spcBef>
                <a:spcPts val="0"/>
              </a:spcBef>
              <a:spcAft>
                <a:spcPts val="0"/>
              </a:spcAft>
            </a:pPr>
            <a:r>
              <a:rPr lang="en-US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 restorer-of-fertility proteins in plant mitochondria</a:t>
            </a:r>
            <a:r>
              <a:rPr lang="en-US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n-US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b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0554B27-4B6B-932C-2871-8438A74B2337}"/>
              </a:ext>
            </a:extLst>
          </p:cNvPr>
          <p:cNvSpPr txBox="1"/>
          <p:nvPr/>
        </p:nvSpPr>
        <p:spPr>
          <a:xfrm>
            <a:off x="187749" y="2492896"/>
            <a:ext cx="8496944" cy="31213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spcBef>
                <a:spcPts val="0"/>
              </a:spcBef>
              <a:spcAft>
                <a:spcPts val="0"/>
              </a:spcAft>
            </a:pP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ang Dang Huynh</a:t>
            </a:r>
            <a:r>
              <a:rPr lang="en-AU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Joanna Melonek</a:t>
            </a:r>
            <a:r>
              <a:rPr lang="en-AU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, Catherine Colas des Francs-Small</a:t>
            </a:r>
            <a:r>
              <a:rPr lang="en-AU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harles S. Bond</a:t>
            </a:r>
            <a:r>
              <a:rPr lang="en-AU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Ian Small</a:t>
            </a:r>
            <a:r>
              <a:rPr lang="en-AU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  <a:p>
            <a:pPr rtl="0">
              <a:spcBef>
                <a:spcPts val="0"/>
              </a:spcBef>
              <a:spcAft>
                <a:spcPts val="0"/>
              </a:spcAft>
            </a:pPr>
            <a:endParaRPr lang="en-AU" sz="1600" b="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rtl="0">
              <a:spcBef>
                <a:spcPts val="0"/>
              </a:spcBef>
              <a:spcAft>
                <a:spcPts val="500"/>
              </a:spcAft>
            </a:pPr>
            <a:r>
              <a:rPr lang="en-AU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C Centre of Excellence in Plant Energy Biology, School of Molecular Sciences, The University of Western Australia, Crawley, WA, Australia</a:t>
            </a:r>
          </a:p>
          <a:p>
            <a:pPr rtl="0">
              <a:spcBef>
                <a:spcPts val="0"/>
              </a:spcBef>
              <a:spcAft>
                <a:spcPts val="500"/>
              </a:spcAft>
            </a:pPr>
            <a:endParaRPr lang="en-AU" sz="1600" b="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rtl="0">
              <a:spcBef>
                <a:spcPts val="0"/>
              </a:spcBef>
              <a:spcAft>
                <a:spcPts val="500"/>
              </a:spcAft>
            </a:pPr>
            <a:r>
              <a:rPr lang="en-AU" sz="16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chool of Molecular Sciences, The University of Western Australia, Crawley, WA</a:t>
            </a:r>
            <a:r>
              <a:rPr lang="en-AU" sz="1600" b="0" i="0" u="none" strike="noStrike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Australia</a:t>
            </a:r>
          </a:p>
          <a:p>
            <a:pPr rtl="0">
              <a:spcBef>
                <a:spcPts val="0"/>
              </a:spcBef>
              <a:spcAft>
                <a:spcPts val="500"/>
              </a:spcAft>
            </a:pPr>
            <a:endParaRPr lang="en-AU" sz="1600" b="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rtl="0">
              <a:spcBef>
                <a:spcPts val="0"/>
              </a:spcBef>
              <a:spcAft>
                <a:spcPts val="500"/>
              </a:spcAft>
            </a:pP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Corresponding authors: </a:t>
            </a:r>
            <a:r>
              <a:rPr lang="en-AU" sz="1600" b="0" i="0" u="sng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joanna.melonek@uwa.edu.au</a:t>
            </a:r>
            <a:r>
              <a:rPr lang="en-AU" sz="16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AU" sz="1600" b="0" i="0" u="sng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  <a:hlinkClick r:id="rId3"/>
              </a:rPr>
              <a:t>ian.small@uwa.edu.au</a:t>
            </a:r>
            <a:endParaRPr lang="en-AU" sz="1600" b="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br>
              <a:rPr lang="en-AU" sz="16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40748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3692088-A720-64FF-AB4A-151B63D44EE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2350" y="44623"/>
            <a:ext cx="4817922" cy="575308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3AF7B6D-0C6F-CF97-8736-B2C223CE8535}"/>
              </a:ext>
            </a:extLst>
          </p:cNvPr>
          <p:cNvSpPr txBox="1"/>
          <p:nvPr/>
        </p:nvSpPr>
        <p:spPr>
          <a:xfrm>
            <a:off x="-460" y="5797713"/>
            <a:ext cx="9237978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ementary Figure 1.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Characterisation of the RFL clade in 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icer arietinum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, 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lycine max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, 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otus japonicus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, 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haseolus vulgaris. </a:t>
            </a:r>
          </a:p>
          <a:p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-class PPR sequences were aligned with Muscle v3.8.425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hlinkClick r:id="rId3"/>
              </a:rPr>
              <a:t>(Edgar, 2004)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nd the tree was generated using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stTree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v2.1.11 </a:t>
            </a:r>
          </a:p>
          <a:p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hlinkClick r:id="rId4"/>
              </a:rPr>
              <a:t>(Price et al., 2010)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in Geneious (</a:t>
            </a:r>
            <a:r>
              <a:rPr lang="en-AU" sz="1200" b="0" i="0" u="sng" strike="noStrike" dirty="0">
                <a:solidFill>
                  <a:srgbClr val="1155CC"/>
                </a:solidFill>
                <a:effectLst/>
                <a:latin typeface="Arial" panose="020B0604020202020204" pitchFamily="34" charset="0"/>
                <a:hlinkClick r:id="rId5"/>
              </a:rPr>
              <a:t>https://www.geneious.com/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. The midpoint rooting was calculated with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TOL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nd tree branches of the </a:t>
            </a:r>
          </a:p>
          <a:p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nal tree were coloured also in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TOL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v6.7.3 (</a:t>
            </a:r>
            <a:r>
              <a:rPr lang="en-AU" sz="1200" b="0" i="0" u="sng" strike="noStrike" dirty="0">
                <a:solidFill>
                  <a:srgbClr val="1155CC"/>
                </a:solidFill>
                <a:effectLst/>
                <a:latin typeface="Arial" panose="020B0604020202020204" pitchFamily="34" charset="0"/>
                <a:hlinkClick r:id="rId6"/>
              </a:rPr>
              <a:t>https://itol.embl.de/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. The RFL clade (shown in blue) was identified through co-location </a:t>
            </a:r>
          </a:p>
          <a:p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 a reference set of 13 Arabidopsis RFL proteins (shown in red), RFL sequences containing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fCTD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re shown in green.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41987467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62"/>
          <a:stretch/>
        </p:blipFill>
        <p:spPr>
          <a:xfrm>
            <a:off x="1150364" y="404664"/>
            <a:ext cx="6734004" cy="496855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13DB324-3B5E-E1D2-41F1-FC4E75354FA0}"/>
              </a:ext>
            </a:extLst>
          </p:cNvPr>
          <p:cNvSpPr txBox="1"/>
          <p:nvPr/>
        </p:nvSpPr>
        <p:spPr>
          <a:xfrm>
            <a:off x="34639" y="5847655"/>
            <a:ext cx="91133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Distance of the last PPR motif from the end of the protein in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Thymus 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quinquecostatus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, Mimulus 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guttatus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</a:p>
          <a:p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Medicago 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runcatula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, Rosa chinensis.  </a:t>
            </a:r>
          </a:p>
        </p:txBody>
      </p:sp>
    </p:spTree>
    <p:extLst>
      <p:ext uri="{BB962C8B-B14F-4D97-AF65-F5344CB8AC3E}">
        <p14:creationId xmlns:p14="http://schemas.microsoft.com/office/powerpoint/2010/main" val="4264851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5806" r="1039"/>
          <a:stretch/>
        </p:blipFill>
        <p:spPr>
          <a:xfrm>
            <a:off x="383541" y="545370"/>
            <a:ext cx="3853080" cy="185763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16532" y="12416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04173" y="246967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C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28" r="3540"/>
          <a:stretch/>
        </p:blipFill>
        <p:spPr>
          <a:xfrm>
            <a:off x="4772976" y="508788"/>
            <a:ext cx="3712117" cy="189951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664872" y="11663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FA8D3B1-3531-9A1E-523E-F00A721F3890}"/>
              </a:ext>
            </a:extLst>
          </p:cNvPr>
          <p:cNvSpPr txBox="1"/>
          <p:nvPr/>
        </p:nvSpPr>
        <p:spPr>
          <a:xfrm>
            <a:off x="-21624" y="5207349"/>
            <a:ext cx="913012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Number of PPR motifs in RFL proteins across 243 genome data sets. </a:t>
            </a:r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 Stacked line plot illustrating the </a:t>
            </a:r>
          </a:p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number of PPR motifs in RFL type proteins. </a:t>
            </a:r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 Number of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RfCTD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proteins with a given number of PPR motifs. </a:t>
            </a:r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 Percentage of</a:t>
            </a:r>
          </a:p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RFL proteins with a given number of PPR motifs in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Glycine max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Gmax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Medicago 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runcatula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Mtruncatula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Lotus japonicu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</a:p>
          <a:p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Cicer arietinum, Thymus 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quinquecostatus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(Thymus),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Mimulus 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guttatus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Mguttatu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Salvia officinali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D9F3527C-618E-7424-B36D-AE0112A92CC0}"/>
              </a:ext>
            </a:extLst>
          </p:cNvPr>
          <p:cNvGrpSpPr/>
          <p:nvPr/>
        </p:nvGrpSpPr>
        <p:grpSpPr>
          <a:xfrm>
            <a:off x="168317" y="2763040"/>
            <a:ext cx="4295754" cy="2232248"/>
            <a:chOff x="143656" y="3284984"/>
            <a:chExt cx="4295754" cy="2232248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678" r="1211" b="3226"/>
            <a:stretch/>
          </p:blipFill>
          <p:spPr>
            <a:xfrm>
              <a:off x="251520" y="3383778"/>
              <a:ext cx="4187890" cy="2133454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33051CEF-414E-37CF-3604-52C118A86910}"/>
                </a:ext>
              </a:extLst>
            </p:cNvPr>
            <p:cNvSpPr/>
            <p:nvPr/>
          </p:nvSpPr>
          <p:spPr>
            <a:xfrm>
              <a:off x="143656" y="3284984"/>
              <a:ext cx="144016" cy="22322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4045538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32C6450F-EA07-2CC2-30EA-791E6AEA3E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5976" y="1649151"/>
            <a:ext cx="2588103" cy="251096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C880AD0-0444-2DB9-2CAE-35F1D0610BC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490"/>
          <a:stretch/>
        </p:blipFill>
        <p:spPr>
          <a:xfrm>
            <a:off x="2199920" y="1564028"/>
            <a:ext cx="2373519" cy="260863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CC59E4B-E787-D5D4-06F8-A969CB317927}"/>
              </a:ext>
            </a:extLst>
          </p:cNvPr>
          <p:cNvSpPr txBox="1"/>
          <p:nvPr/>
        </p:nvSpPr>
        <p:spPr>
          <a:xfrm>
            <a:off x="3046084" y="1332057"/>
            <a:ext cx="59125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Cycas</a:t>
            </a:r>
          </a:p>
          <a:p>
            <a:endParaRPr lang="en-AU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F5EDFB0-4D1D-3CB9-078B-EA321F2CCBEA}"/>
              </a:ext>
            </a:extLst>
          </p:cNvPr>
          <p:cNvSpPr txBox="1"/>
          <p:nvPr/>
        </p:nvSpPr>
        <p:spPr>
          <a:xfrm>
            <a:off x="5302736" y="1332057"/>
            <a:ext cx="78143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Conifers</a:t>
            </a:r>
          </a:p>
          <a:p>
            <a:endParaRPr lang="en-AU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610E7FC-9CB9-1674-516F-DCDC84B20573}"/>
              </a:ext>
            </a:extLst>
          </p:cNvPr>
          <p:cNvSpPr txBox="1"/>
          <p:nvPr/>
        </p:nvSpPr>
        <p:spPr>
          <a:xfrm>
            <a:off x="852858" y="1338467"/>
            <a:ext cx="69480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Ginkgo</a:t>
            </a:r>
          </a:p>
          <a:p>
            <a:endParaRPr lang="en-AU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FFF4C83-D5A3-37A8-5875-F3782DC50ED4}"/>
              </a:ext>
            </a:extLst>
          </p:cNvPr>
          <p:cNvSpPr txBox="1"/>
          <p:nvPr/>
        </p:nvSpPr>
        <p:spPr>
          <a:xfrm>
            <a:off x="2555776" y="4160114"/>
            <a:ext cx="151859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/>
              <a:t>Cycas </a:t>
            </a:r>
            <a:r>
              <a:rPr lang="en-AU" sz="1200" i="1" dirty="0" err="1"/>
              <a:t>panzhihuaensis</a:t>
            </a:r>
            <a:endParaRPr lang="en-AU" sz="1200" i="1" dirty="0"/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303D0A57-BEE0-1690-04A4-D25165FF70E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770"/>
          <a:stretch/>
        </p:blipFill>
        <p:spPr>
          <a:xfrm>
            <a:off x="35496" y="1866116"/>
            <a:ext cx="2351931" cy="2166992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09F00DFD-A49B-05C3-9B48-1C3D06BDA786}"/>
              </a:ext>
            </a:extLst>
          </p:cNvPr>
          <p:cNvSpPr txBox="1"/>
          <p:nvPr/>
        </p:nvSpPr>
        <p:spPr>
          <a:xfrm>
            <a:off x="652741" y="4160113"/>
            <a:ext cx="10389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/>
              <a:t>G</a:t>
            </a:r>
            <a:r>
              <a:rPr lang="en-AU" sz="1200" i="1" dirty="0" err="1"/>
              <a:t>inkgo</a:t>
            </a:r>
            <a:r>
              <a:rPr lang="en-AU" sz="1200" i="1" dirty="0"/>
              <a:t> biloba</a:t>
            </a:r>
            <a:endParaRPr lang="en-AU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559F8F-8956-A99D-1E64-E46674E49A4C}"/>
              </a:ext>
            </a:extLst>
          </p:cNvPr>
          <p:cNvSpPr txBox="1"/>
          <p:nvPr/>
        </p:nvSpPr>
        <p:spPr>
          <a:xfrm>
            <a:off x="683568" y="611396"/>
            <a:ext cx="29523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dirty="0"/>
              <a:t>Gymnosperm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69C3757-CE16-4966-4E6E-8B9D061DA946}"/>
              </a:ext>
            </a:extLst>
          </p:cNvPr>
          <p:cNvSpPr txBox="1"/>
          <p:nvPr/>
        </p:nvSpPr>
        <p:spPr>
          <a:xfrm>
            <a:off x="66845" y="5001752"/>
            <a:ext cx="8712968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ementary Figure 4.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Characterisation of the 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</a:rPr>
              <a:t>P class subfamily 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g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ymnosperms.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 class PPR sequences were aligned with Muscle v3.8.425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hlinkClick r:id="rId5"/>
              </a:rPr>
              <a:t>(Edgar, 2004)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nd the tree was generated using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stTree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v2.1.11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hlinkClick r:id="rId6"/>
              </a:rPr>
              <a:t>(Price et al., 2010)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in Geneious (</a:t>
            </a:r>
            <a:r>
              <a:rPr lang="en-AU" sz="1200" b="0" i="0" u="sng" strike="noStrike" dirty="0">
                <a:solidFill>
                  <a:srgbClr val="1155CC"/>
                </a:solidFill>
                <a:effectLst/>
                <a:latin typeface="Arial" panose="020B0604020202020204" pitchFamily="34" charset="0"/>
                <a:hlinkClick r:id="rId7"/>
              </a:rPr>
              <a:t>https://www.geneious.com/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. The midpoint rooting was calculated with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TOL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nd tree branches of the final tree were coloured also in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TOL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v6.7.3 (</a:t>
            </a:r>
            <a:r>
              <a:rPr lang="en-AU" sz="1200" b="0" i="0" u="sng" strike="noStrike" dirty="0">
                <a:solidFill>
                  <a:srgbClr val="1155CC"/>
                </a:solidFill>
                <a:effectLst/>
                <a:latin typeface="Arial" panose="020B0604020202020204" pitchFamily="34" charset="0"/>
                <a:hlinkClick r:id="rId8"/>
              </a:rPr>
              <a:t>https://itol.embl.de/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. The clade of 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</a:rPr>
              <a:t>Arabidopsis full-length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FLs is coloured in red. A clade of P class PPR sequences 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</a:rPr>
              <a:t>of 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. </a:t>
            </a:r>
            <a:r>
              <a:rPr lang="en-AU" sz="1200" b="0" i="1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aeda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AU" sz="1200" b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ocated in genomic clusters is shown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 blue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4E09A1D-7B2C-B84C-AD30-54F24974C73A}"/>
              </a:ext>
            </a:extLst>
          </p:cNvPr>
          <p:cNvSpPr txBox="1"/>
          <p:nvPr/>
        </p:nvSpPr>
        <p:spPr>
          <a:xfrm>
            <a:off x="7487278" y="1338467"/>
            <a:ext cx="8291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err="1"/>
              <a:t>Gnetales</a:t>
            </a:r>
            <a:endParaRPr lang="en-AU" sz="1400" dirty="0"/>
          </a:p>
          <a:p>
            <a:endParaRPr lang="en-AU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A5EA5FF-35D8-0AEC-E91E-ED6C15084905}"/>
              </a:ext>
            </a:extLst>
          </p:cNvPr>
          <p:cNvSpPr txBox="1"/>
          <p:nvPr/>
        </p:nvSpPr>
        <p:spPr>
          <a:xfrm>
            <a:off x="5076056" y="4149080"/>
            <a:ext cx="10790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/>
              <a:t>Pinus </a:t>
            </a:r>
            <a:r>
              <a:rPr lang="en-AU" sz="1200" i="1" dirty="0" err="1"/>
              <a:t>taeda</a:t>
            </a:r>
            <a:endParaRPr lang="en-AU" sz="1200" i="1" dirty="0"/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6EB3A446-DFF9-0FC4-3783-B83C7EDD2CF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742360" y="1648745"/>
            <a:ext cx="2394618" cy="2384363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4B14AB89-1B67-3A8A-B455-74C6FAED3CD4}"/>
              </a:ext>
            </a:extLst>
          </p:cNvPr>
          <p:cNvSpPr txBox="1"/>
          <p:nvPr/>
        </p:nvSpPr>
        <p:spPr>
          <a:xfrm>
            <a:off x="7092280" y="4160113"/>
            <a:ext cx="161737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 err="1"/>
              <a:t>Gnetum</a:t>
            </a:r>
            <a:r>
              <a:rPr lang="en-AU" sz="1200" i="1" dirty="0"/>
              <a:t> </a:t>
            </a:r>
            <a:r>
              <a:rPr lang="en-AU" sz="1200" i="1" dirty="0" err="1"/>
              <a:t>montanum</a:t>
            </a:r>
            <a:endParaRPr lang="en-AU" sz="1200" i="1" dirty="0"/>
          </a:p>
        </p:txBody>
      </p:sp>
    </p:spTree>
    <p:extLst>
      <p:ext uri="{BB962C8B-B14F-4D97-AF65-F5344CB8AC3E}">
        <p14:creationId xmlns:p14="http://schemas.microsoft.com/office/powerpoint/2010/main" val="15247015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DF5EDFB0-4D1D-3CB9-078B-EA321F2CCBEA}"/>
              </a:ext>
            </a:extLst>
          </p:cNvPr>
          <p:cNvSpPr txBox="1"/>
          <p:nvPr/>
        </p:nvSpPr>
        <p:spPr>
          <a:xfrm>
            <a:off x="5302736" y="1332057"/>
            <a:ext cx="78143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Conifers</a:t>
            </a:r>
          </a:p>
          <a:p>
            <a:endParaRPr lang="en-AU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559F8F-8956-A99D-1E64-E46674E49A4C}"/>
              </a:ext>
            </a:extLst>
          </p:cNvPr>
          <p:cNvSpPr txBox="1"/>
          <p:nvPr/>
        </p:nvSpPr>
        <p:spPr>
          <a:xfrm>
            <a:off x="215516" y="188640"/>
            <a:ext cx="29523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dirty="0"/>
              <a:t>Gymnosperm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69C3757-CE16-4966-4E6E-8B9D061DA946}"/>
              </a:ext>
            </a:extLst>
          </p:cNvPr>
          <p:cNvSpPr txBox="1"/>
          <p:nvPr/>
        </p:nvSpPr>
        <p:spPr>
          <a:xfrm>
            <a:off x="66845" y="5180999"/>
            <a:ext cx="8712968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spcBef>
                <a:spcPts val="0"/>
              </a:spcBef>
              <a:spcAft>
                <a:spcPts val="1200"/>
              </a:spcAft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Figure 5.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volutionary relationships among P class PPR proteins in conifers. 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sz="120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hylogenetic relationships among the P class PPR sequences in Chinese pine (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inus </a:t>
            </a:r>
            <a:r>
              <a:rPr lang="en-US" sz="1200" b="0" i="1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buliformis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. The P class sequences clustering on chromosomes 8 and 5 are highlighted in blue. 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hylogenetic relationships among P class PPR sequences in 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200" b="0" i="1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buliformis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three other conifer species 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Pinus </a:t>
            </a:r>
            <a:r>
              <a:rPr lang="en-US" sz="1200" b="0" i="1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eda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b="0" i="1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seudotsuga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1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nziesii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inus </a:t>
            </a:r>
            <a:r>
              <a:rPr lang="en-US" sz="1200" b="0" i="1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ambertiana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P-class PPR sequences were aligned with Muscle v 3.8.425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(Edgar, 2004)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the tree was generated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astTre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v2.1.11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  <a:hlinkClick r:id="rId3"/>
              </a:rPr>
              <a:t>(Price et al., 2010)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Tree branches were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loure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Geneious (</a:t>
            </a:r>
            <a:r>
              <a:rPr lang="en-US" sz="1200" b="0" i="0" u="sng" strike="noStrike" dirty="0">
                <a:solidFill>
                  <a:srgbClr val="1155CC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https://www.geneious.com/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. The clade of 13 Arabidopsis RFL sequences used as a reference is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loure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red.  </a:t>
            </a:r>
            <a:endParaRPr lang="en-US" sz="1200" b="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F0F4361C-B4FD-FAC8-20D1-4128E1549B8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978" y="718575"/>
            <a:ext cx="7776865" cy="43018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026219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431F5D95-B59D-4A84-60B5-02F4C736A2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7704" y="1706562"/>
            <a:ext cx="2631317" cy="249550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F54DB67-68A7-2E16-0472-A04F027173C0}"/>
              </a:ext>
            </a:extLst>
          </p:cNvPr>
          <p:cNvSpPr txBox="1"/>
          <p:nvPr/>
        </p:nvSpPr>
        <p:spPr>
          <a:xfrm>
            <a:off x="611560" y="1422835"/>
            <a:ext cx="120962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500" dirty="0" err="1"/>
              <a:t>Amborellales</a:t>
            </a:r>
            <a:endParaRPr lang="en-AU" sz="1500" dirty="0"/>
          </a:p>
          <a:p>
            <a:endParaRPr lang="en-AU" sz="15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7386F86-DAB0-4946-FB33-91B1D7438EEE}"/>
              </a:ext>
            </a:extLst>
          </p:cNvPr>
          <p:cNvSpPr txBox="1"/>
          <p:nvPr/>
        </p:nvSpPr>
        <p:spPr>
          <a:xfrm>
            <a:off x="2673392" y="1412895"/>
            <a:ext cx="11785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err="1"/>
              <a:t>Nymphaeales</a:t>
            </a:r>
            <a:endParaRPr lang="en-AU" sz="1400" dirty="0"/>
          </a:p>
          <a:p>
            <a:endParaRPr lang="en-AU" sz="14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473CF94-481A-1FD3-2BFF-18220114A47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353" r="5390"/>
          <a:stretch/>
        </p:blipFill>
        <p:spPr>
          <a:xfrm>
            <a:off x="35496" y="1706563"/>
            <a:ext cx="2268783" cy="259137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58D3757-4906-3C31-A97B-E7080A6929E9}"/>
              </a:ext>
            </a:extLst>
          </p:cNvPr>
          <p:cNvSpPr txBox="1"/>
          <p:nvPr/>
        </p:nvSpPr>
        <p:spPr>
          <a:xfrm>
            <a:off x="141494" y="4287286"/>
            <a:ext cx="15392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 err="1"/>
              <a:t>Amborella</a:t>
            </a:r>
            <a:r>
              <a:rPr lang="en-AU" sz="1200" i="1" dirty="0"/>
              <a:t> </a:t>
            </a:r>
            <a:r>
              <a:rPr lang="en-AU" sz="1200" i="1" dirty="0" err="1"/>
              <a:t>trichopoda</a:t>
            </a:r>
            <a:endParaRPr lang="en-AU" sz="1200" i="1" dirty="0"/>
          </a:p>
          <a:p>
            <a:endParaRPr lang="en-AU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4C3CF77-4236-273C-5B35-91F07C56CE45}"/>
              </a:ext>
            </a:extLst>
          </p:cNvPr>
          <p:cNvSpPr txBox="1"/>
          <p:nvPr/>
        </p:nvSpPr>
        <p:spPr>
          <a:xfrm>
            <a:off x="1197228" y="1104803"/>
            <a:ext cx="29523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dirty="0">
                <a:solidFill>
                  <a:srgbClr val="000000"/>
                </a:solidFill>
                <a:latin typeface="Calibri" panose="020F0502020204030204" pitchFamily="34" charset="0"/>
              </a:rPr>
              <a:t>Basal angiosperms</a:t>
            </a:r>
            <a:endParaRPr lang="en-AU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CD8754-B373-3C6E-4C96-127FFC2FEAE3}"/>
              </a:ext>
            </a:extLst>
          </p:cNvPr>
          <p:cNvSpPr txBox="1"/>
          <p:nvPr/>
        </p:nvSpPr>
        <p:spPr>
          <a:xfrm>
            <a:off x="2555776" y="4279639"/>
            <a:ext cx="1412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Nymphaea </a:t>
            </a:r>
            <a:r>
              <a:rPr lang="en-AU" sz="1200" i="1" dirty="0" err="1"/>
              <a:t>colorata</a:t>
            </a:r>
            <a:endParaRPr lang="en-AU" sz="12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9257AA8-2E8B-685B-4138-5D2C6A42687C}"/>
              </a:ext>
            </a:extLst>
          </p:cNvPr>
          <p:cNvSpPr txBox="1"/>
          <p:nvPr/>
        </p:nvSpPr>
        <p:spPr>
          <a:xfrm>
            <a:off x="4858518" y="4255928"/>
            <a:ext cx="1657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 err="1"/>
              <a:t>Chloranthus</a:t>
            </a:r>
            <a:r>
              <a:rPr lang="en-AU" sz="1200" i="1" dirty="0"/>
              <a:t> </a:t>
            </a:r>
            <a:r>
              <a:rPr lang="en-AU" sz="1200" i="1" dirty="0" err="1"/>
              <a:t>sessilifolius</a:t>
            </a:r>
            <a:endParaRPr lang="en-AU" sz="1200" i="1" dirty="0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3513438E-DCCC-1CDB-191B-3450D4B9F0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32240" y="1642876"/>
            <a:ext cx="2364722" cy="2591373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C359F2EB-970E-E33A-AC1E-DCA3BB1DD7A2}"/>
              </a:ext>
            </a:extLst>
          </p:cNvPr>
          <p:cNvSpPr txBox="1"/>
          <p:nvPr/>
        </p:nvSpPr>
        <p:spPr>
          <a:xfrm>
            <a:off x="7036897" y="4190429"/>
            <a:ext cx="18942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 err="1"/>
              <a:t>Chloranthus</a:t>
            </a:r>
            <a:r>
              <a:rPr lang="en-AU" sz="1200" i="1" dirty="0"/>
              <a:t> </a:t>
            </a:r>
            <a:r>
              <a:rPr lang="en-AU" sz="1200" i="1" dirty="0" err="1"/>
              <a:t>sessilifolius</a:t>
            </a:r>
            <a:endParaRPr lang="en-AU" sz="1200" i="1" dirty="0"/>
          </a:p>
          <a:p>
            <a:r>
              <a:rPr lang="en-AU" sz="1200" i="1" dirty="0"/>
              <a:t>and </a:t>
            </a:r>
            <a:r>
              <a:rPr lang="en-AU" sz="1200" i="1" dirty="0" err="1"/>
              <a:t>Persea</a:t>
            </a:r>
            <a:r>
              <a:rPr lang="en-AU" sz="1200" i="1" dirty="0"/>
              <a:t> americana </a:t>
            </a:r>
            <a:r>
              <a:rPr lang="en-AU" sz="1200" dirty="0"/>
              <a:t>Has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21AAAF2-9476-F74F-544F-5621F51EC161}"/>
              </a:ext>
            </a:extLst>
          </p:cNvPr>
          <p:cNvSpPr txBox="1"/>
          <p:nvPr/>
        </p:nvSpPr>
        <p:spPr>
          <a:xfrm>
            <a:off x="45442" y="5180999"/>
            <a:ext cx="871296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ementary Figure </a:t>
            </a:r>
            <a:r>
              <a:rPr lang="en-AU" sz="1200" b="1" dirty="0">
                <a:solidFill>
                  <a:srgbClr val="000000"/>
                </a:solidFill>
                <a:latin typeface="Arial" panose="020B0604020202020204" pitchFamily="34" charset="0"/>
              </a:rPr>
              <a:t>6</a:t>
            </a:r>
            <a:r>
              <a:rPr lang="en-AU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Characterisation of the 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</a:rPr>
              <a:t>P class subfamily in basal angiosperms (</a:t>
            </a:r>
            <a:r>
              <a:rPr lang="en-AU" sz="1200" i="1" dirty="0" err="1"/>
              <a:t>Amborella</a:t>
            </a:r>
            <a:r>
              <a:rPr lang="en-AU" sz="1200" i="1" dirty="0"/>
              <a:t> </a:t>
            </a:r>
            <a:r>
              <a:rPr lang="en-AU" sz="1200" i="1" dirty="0" err="1"/>
              <a:t>trichopoda</a:t>
            </a:r>
            <a:r>
              <a:rPr lang="en-AU" sz="1200" i="1" dirty="0"/>
              <a:t>, Nymphaea </a:t>
            </a:r>
            <a:r>
              <a:rPr lang="en-AU" sz="1200" i="1" dirty="0" err="1"/>
              <a:t>colorata</a:t>
            </a:r>
            <a:r>
              <a:rPr lang="en-AU" sz="1200" i="1" dirty="0"/>
              <a:t>) </a:t>
            </a:r>
            <a:r>
              <a:rPr lang="en-AU" sz="1200" dirty="0"/>
              <a:t>(ANA grade) </a:t>
            </a:r>
            <a:r>
              <a:rPr lang="en-AU" sz="1200" i="1" dirty="0"/>
              <a:t>and </a:t>
            </a:r>
            <a:r>
              <a:rPr lang="en-AU" sz="1200" i="1" dirty="0" err="1"/>
              <a:t>Chloranthus</a:t>
            </a:r>
            <a:r>
              <a:rPr lang="en-AU" sz="1200" i="1" dirty="0"/>
              <a:t> </a:t>
            </a:r>
            <a:r>
              <a:rPr lang="en-AU" sz="1200" i="1" dirty="0" err="1"/>
              <a:t>sessilifolius</a:t>
            </a:r>
            <a:r>
              <a:rPr lang="en-AU" sz="1200" i="1" dirty="0"/>
              <a:t>. </a:t>
            </a:r>
            <a:r>
              <a:rPr lang="en-AU" sz="1200" b="0" i="0" u="none" strike="noStrike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 class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PR sequences were aligned with Muscle v3.8.425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hlinkClick r:id="rId5"/>
              </a:rPr>
              <a:t>(Edgar, 2004)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nd the tree was generated using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stTree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v2.1.11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hlinkClick r:id="rId6"/>
              </a:rPr>
              <a:t>(Price et al., 2010)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in Geneious (</a:t>
            </a:r>
            <a:r>
              <a:rPr lang="en-AU" sz="1200" b="0" i="0" u="sng" strike="noStrike" dirty="0">
                <a:solidFill>
                  <a:srgbClr val="1155CC"/>
                </a:solidFill>
                <a:effectLst/>
                <a:latin typeface="Arial" panose="020B0604020202020204" pitchFamily="34" charset="0"/>
                <a:hlinkClick r:id="rId7"/>
              </a:rPr>
              <a:t>https://www.geneious.com/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. The midpoint rooting was calculated with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TOL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nd tree branches of the final tree were coloured also in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TOL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v6.7.3 (</a:t>
            </a:r>
            <a:r>
              <a:rPr lang="en-AU" sz="1200" b="0" i="0" u="sng" strike="noStrike" dirty="0">
                <a:solidFill>
                  <a:srgbClr val="1155CC"/>
                </a:solidFill>
                <a:effectLst/>
                <a:latin typeface="Arial" panose="020B0604020202020204" pitchFamily="34" charset="0"/>
                <a:hlinkClick r:id="rId8"/>
              </a:rPr>
              <a:t>https://itol.embl.de/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. The clade of 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</a:rPr>
              <a:t>Arabidopsis full-length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FLs is coloured in red. 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</a:rPr>
              <a:t>T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e RFL clade in 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. americana </a:t>
            </a:r>
            <a:r>
              <a:rPr lang="en-AU" sz="1200" b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s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own in green and similar sequences in 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. </a:t>
            </a:r>
            <a:r>
              <a:rPr lang="en-AU" sz="1200" b="0" i="1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essilifolius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re shown in blue, respectively. 13 of the 21 RFL sequences in </a:t>
            </a:r>
            <a:r>
              <a:rPr lang="en-AU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. americana </a:t>
            </a:r>
            <a:r>
              <a:rPr lang="en-AU" sz="1200" b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ass 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ave </a:t>
            </a:r>
            <a:r>
              <a:rPr lang="en-AU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fCTD</a:t>
            </a:r>
            <a:r>
              <a:rPr lang="en-AU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613943F-630E-DEC7-6063-1E7CF065286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231"/>
          <a:stretch/>
        </p:blipFill>
        <p:spPr>
          <a:xfrm>
            <a:off x="4283968" y="1610697"/>
            <a:ext cx="2608913" cy="259137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14BBEDE-CFE2-CA47-2A76-33A1810E843F}"/>
              </a:ext>
            </a:extLst>
          </p:cNvPr>
          <p:cNvSpPr txBox="1"/>
          <p:nvPr/>
        </p:nvSpPr>
        <p:spPr>
          <a:xfrm>
            <a:off x="5004048" y="1425381"/>
            <a:ext cx="119404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Chloranthales</a:t>
            </a:r>
          </a:p>
          <a:p>
            <a:endParaRPr lang="en-AU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0E8A327-419F-78AC-663F-66A63F865FB6}"/>
              </a:ext>
            </a:extLst>
          </p:cNvPr>
          <p:cNvSpPr txBox="1"/>
          <p:nvPr/>
        </p:nvSpPr>
        <p:spPr>
          <a:xfrm>
            <a:off x="6732240" y="1425437"/>
            <a:ext cx="23546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Chloranthales and Magnoliids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350610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a5f62281-3d98-49bb-ac9a-42847faaf231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42F68290EB5B04E80A4F70B9346CBB3" ma:contentTypeVersion="15" ma:contentTypeDescription="Create a new document." ma:contentTypeScope="" ma:versionID="a4e6c72b95b224b4431a3f941ac4fbf2">
  <xsd:schema xmlns:xsd="http://www.w3.org/2001/XMLSchema" xmlns:xs="http://www.w3.org/2001/XMLSchema" xmlns:p="http://schemas.microsoft.com/office/2006/metadata/properties" xmlns:ns3="a5f62281-3d98-49bb-ac9a-42847faaf231" xmlns:ns4="6bdc1653-49e6-41a4-a88c-bdbd3a3b7e7e" targetNamespace="http://schemas.microsoft.com/office/2006/metadata/properties" ma:root="true" ma:fieldsID="383219302b8d84c8ac6b1c39f833ae08" ns3:_="" ns4:_="">
    <xsd:import namespace="a5f62281-3d98-49bb-ac9a-42847faaf231"/>
    <xsd:import namespace="6bdc1653-49e6-41a4-a88c-bdbd3a3b7e7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f62281-3d98-49bb-ac9a-42847faaf2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bdc1653-49e6-41a4-a88c-bdbd3a3b7e7e" elementFormDefault="qualified">
    <xsd:import namespace="http://schemas.microsoft.com/office/2006/documentManagement/types"/>
    <xsd:import namespace="http://schemas.microsoft.com/office/infopath/2007/PartnerControls"/>
    <xsd:element name="SharedWithUsers" ma:index="1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3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B2D70FD-47D9-4F7E-8019-885BCAF40A88}">
  <ds:schemaRefs>
    <ds:schemaRef ds:uri="http://schemas.microsoft.com/office/2006/documentManagement/types"/>
    <ds:schemaRef ds:uri="http://purl.org/dc/terms/"/>
    <ds:schemaRef ds:uri="http://purl.org/dc/dcmitype/"/>
    <ds:schemaRef ds:uri="http://schemas.openxmlformats.org/package/2006/metadata/core-properties"/>
    <ds:schemaRef ds:uri="6bdc1653-49e6-41a4-a88c-bdbd3a3b7e7e"/>
    <ds:schemaRef ds:uri="http://purl.org/dc/elements/1.1/"/>
    <ds:schemaRef ds:uri="http://schemas.microsoft.com/office/2006/metadata/properties"/>
    <ds:schemaRef ds:uri="http://schemas.microsoft.com/office/infopath/2007/PartnerControls"/>
    <ds:schemaRef ds:uri="a5f62281-3d98-49bb-ac9a-42847faaf231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A32CCE23-A904-4AEB-A8C8-16398C0A7A5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5f62281-3d98-49bb-ac9a-42847faaf231"/>
    <ds:schemaRef ds:uri="6bdc1653-49e6-41a4-a88c-bdbd3a3b7e7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C278BC4-1784-4DBA-A495-72C72419563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792</TotalTime>
  <Words>783</Words>
  <Application>Microsoft Office PowerPoint</Application>
  <PresentationFormat>On-screen Show (4:3)</PresentationFormat>
  <Paragraphs>5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a Melonek</dc:creator>
  <cp:lastModifiedBy>Joanna Melonek</cp:lastModifiedBy>
  <cp:revision>57</cp:revision>
  <dcterms:created xsi:type="dcterms:W3CDTF">2016-10-31T09:57:58Z</dcterms:created>
  <dcterms:modified xsi:type="dcterms:W3CDTF">2023-05-02T06:47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42F68290EB5B04E80A4F70B9346CBB3</vt:lpwstr>
  </property>
</Properties>
</file>